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136" d="100"/>
          <a:sy n="136" d="100"/>
        </p:scale>
        <p:origin x="-1664" y="-104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AE69CF-43F8-4549-AF85-171D88DC8F27}" type="datetimeFigureOut">
              <a:rPr lang="en-US" smtClean="0"/>
              <a:t>1/10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526B0F-81CF-4861-85AD-45090C977FF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6768296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AE69CF-43F8-4549-AF85-171D88DC8F27}" type="datetimeFigureOut">
              <a:rPr lang="en-US" smtClean="0"/>
              <a:t>1/10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526B0F-81CF-4861-85AD-45090C977FF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6378165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AE69CF-43F8-4549-AF85-171D88DC8F27}" type="datetimeFigureOut">
              <a:rPr lang="en-US" smtClean="0"/>
              <a:t>1/10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526B0F-81CF-4861-85AD-45090C977FF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5895335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AE69CF-43F8-4549-AF85-171D88DC8F27}" type="datetimeFigureOut">
              <a:rPr lang="en-US" smtClean="0"/>
              <a:t>1/10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526B0F-81CF-4861-85AD-45090C977FF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2489728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AE69CF-43F8-4549-AF85-171D88DC8F27}" type="datetimeFigureOut">
              <a:rPr lang="en-US" smtClean="0"/>
              <a:t>1/10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526B0F-81CF-4861-85AD-45090C977FF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5211654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AE69CF-43F8-4549-AF85-171D88DC8F27}" type="datetimeFigureOut">
              <a:rPr lang="en-US" smtClean="0"/>
              <a:t>1/10/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526B0F-81CF-4861-85AD-45090C977FF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2318420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AE69CF-43F8-4549-AF85-171D88DC8F27}" type="datetimeFigureOut">
              <a:rPr lang="en-US" smtClean="0"/>
              <a:t>1/10/1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526B0F-81CF-4861-85AD-45090C977FF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4535454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AE69CF-43F8-4549-AF85-171D88DC8F27}" type="datetimeFigureOut">
              <a:rPr lang="en-US" smtClean="0"/>
              <a:t>1/10/1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526B0F-81CF-4861-85AD-45090C977FF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7145472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AE69CF-43F8-4549-AF85-171D88DC8F27}" type="datetimeFigureOut">
              <a:rPr lang="en-US" smtClean="0"/>
              <a:t>1/10/1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526B0F-81CF-4861-85AD-45090C977FF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6335021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AE69CF-43F8-4549-AF85-171D88DC8F27}" type="datetimeFigureOut">
              <a:rPr lang="en-US" smtClean="0"/>
              <a:t>1/10/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526B0F-81CF-4861-85AD-45090C977FF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4569985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AE69CF-43F8-4549-AF85-171D88DC8F27}" type="datetimeFigureOut">
              <a:rPr lang="en-US" smtClean="0"/>
              <a:t>1/10/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526B0F-81CF-4861-85AD-45090C977FF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8756741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6AE69CF-43F8-4549-AF85-171D88DC8F27}" type="datetimeFigureOut">
              <a:rPr lang="en-US" smtClean="0"/>
              <a:t>1/10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A526B0F-81CF-4861-85AD-45090C977FF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1562588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Group 168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26218242"/>
              </p:ext>
            </p:extLst>
          </p:nvPr>
        </p:nvGraphicFramePr>
        <p:xfrm>
          <a:off x="304800" y="838200"/>
          <a:ext cx="7372313" cy="5394960"/>
        </p:xfrm>
        <a:graphic>
          <a:graphicData uri="http://schemas.openxmlformats.org/drawingml/2006/table">
            <a:tbl>
              <a:tblPr/>
              <a:tblGrid>
                <a:gridCol w="2549414"/>
                <a:gridCol w="4822899"/>
              </a:tblGrid>
              <a:tr h="609600"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8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</a:rPr>
                        <a:t>Epigenetic regulators</a:t>
                      </a:r>
                    </a:p>
                  </a:txBody>
                  <a:tcPr marL="68580" marR="68580" marT="0" marB="0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600" b="0" i="1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</a:rPr>
                        <a:t>IDH1, IDH2, DNMT3A, TET2, EZH2, ASXL1, KDM6A/UTX, SUZ12</a:t>
                      </a:r>
                    </a:p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6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</a:rPr>
                        <a:t> </a:t>
                      </a:r>
                    </a:p>
                  </a:txBody>
                  <a:tcPr marL="68580" marR="68580" marT="0" marB="0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bg1"/>
                    </a:solidFill>
                  </a:tcPr>
                </a:tc>
              </a:tr>
              <a:tr h="609600"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</a:rPr>
                        <a:t>Spliceosomal genes</a:t>
                      </a:r>
                      <a:endParaRPr kumimoji="0" lang="en-US" sz="18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</a:endParaRPr>
                    </a:p>
                  </a:txBody>
                  <a:tcPr marL="68580" marR="68580" marT="0" marB="0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600" b="0" i="1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</a:rPr>
                        <a:t>SF3B1, SRSF2, ZRSR2, U2AF1</a:t>
                      </a:r>
                    </a:p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6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</a:rPr>
                        <a:t> </a:t>
                      </a:r>
                    </a:p>
                  </a:txBody>
                  <a:tcPr marL="68580" marR="68580" marT="0" marB="0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bg1"/>
                    </a:solidFill>
                  </a:tcPr>
                </a:tc>
              </a:tr>
              <a:tr h="457200"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8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</a:rPr>
                        <a:t>Receptor tyrosine kinase</a:t>
                      </a:r>
                    </a:p>
                  </a:txBody>
                  <a:tcPr marL="68580" marR="68580" marT="0" marB="0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600" b="0" i="1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</a:rPr>
                        <a:t>FLT3, KIT</a:t>
                      </a:r>
                    </a:p>
                  </a:txBody>
                  <a:tcPr marL="68580" marR="68580" marT="0" marB="0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bg1"/>
                    </a:solidFill>
                  </a:tcPr>
                </a:tc>
              </a:tr>
              <a:tr h="457200"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8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</a:rPr>
                        <a:t>Cytoplasmic tyrosine kinase</a:t>
                      </a:r>
                    </a:p>
                  </a:txBody>
                  <a:tcPr marL="68580" marR="68580" marT="0" marB="0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600" b="0" i="1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</a:rPr>
                        <a:t>JAK1, JAK2, JAK3, ABL1</a:t>
                      </a:r>
                    </a:p>
                  </a:txBody>
                  <a:tcPr marL="68580" marR="68580" marT="0" marB="0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533400"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8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</a:rPr>
                        <a:t>Signaling molecules </a:t>
                      </a:r>
                    </a:p>
                  </a:txBody>
                  <a:tcPr marL="68580" marR="68580" marT="0" marB="0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600" b="0" i="1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</a:rPr>
                        <a:t>CBL, CBLB, NRAS, KRAS, HRAS</a:t>
                      </a:r>
                    </a:p>
                  </a:txBody>
                  <a:tcPr marL="68580" marR="68580" marT="0" marB="0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533400"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8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</a:rPr>
                        <a:t>Cytokine receptor</a:t>
                      </a:r>
                    </a:p>
                  </a:txBody>
                  <a:tcPr marL="68580" marR="68580" marT="0" marB="0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600" b="0" i="1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</a:rPr>
                        <a:t>MPL, IL7R, CSF3R</a:t>
                      </a:r>
                    </a:p>
                  </a:txBody>
                  <a:tcPr marL="68580" marR="68580" marT="0" marB="0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533400"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8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</a:rPr>
                        <a:t>Phosphatase</a:t>
                      </a:r>
                    </a:p>
                  </a:txBody>
                  <a:tcPr marL="68580" marR="68580" marT="0" marB="0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600" b="0" i="1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</a:rPr>
                        <a:t>PTPN11</a:t>
                      </a:r>
                    </a:p>
                  </a:txBody>
                  <a:tcPr marL="68580" marR="68580" marT="0" marB="0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533400"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8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</a:rPr>
                        <a:t>Transcriptional factor</a:t>
                      </a:r>
                    </a:p>
                  </a:txBody>
                  <a:tcPr marL="68580" marR="68580" marT="0" marB="0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600" b="0" i="1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</a:rPr>
                        <a:t>GATA1, GATA2, CEBPA, ETV6, RUNX1, STAT3, PAX5, IKZF1</a:t>
                      </a:r>
                    </a:p>
                  </a:txBody>
                  <a:tcPr marL="68580" marR="68580" marT="0" marB="0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bg1"/>
                    </a:solidFill>
                  </a:tcPr>
                </a:tc>
              </a:tr>
              <a:tr h="457200"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8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</a:rPr>
                        <a:t>Tumor Suppressor</a:t>
                      </a:r>
                    </a:p>
                  </a:txBody>
                  <a:tcPr marL="68580" marR="68580" marT="0" marB="0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600" b="0" i="1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</a:rPr>
                        <a:t>TP53, WT1</a:t>
                      </a:r>
                    </a:p>
                  </a:txBody>
                  <a:tcPr marL="68580" marR="68580" marT="0" marB="0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457200"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8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</a:rPr>
                        <a:t>Other</a:t>
                      </a:r>
                    </a:p>
                  </a:txBody>
                  <a:tcPr marL="68580" marR="68580" marT="0" marB="0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1600" b="0" i="1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</a:rPr>
                        <a:t>FBXW7, CREBBP, NOTCH1, BCOR, NPM1</a:t>
                      </a:r>
                    </a:p>
                  </a:txBody>
                  <a:tcPr marL="68580" marR="68580" marT="0" marB="0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</a:tbl>
          </a:graphicData>
        </a:graphic>
      </p:graphicFrame>
      <p:sp>
        <p:nvSpPr>
          <p:cNvPr id="5" name="TextBox 4"/>
          <p:cNvSpPr txBox="1"/>
          <p:nvPr/>
        </p:nvSpPr>
        <p:spPr>
          <a:xfrm>
            <a:off x="228600" y="304800"/>
            <a:ext cx="51269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Table 1: Genes tested by next generation sequencing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105581224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105</Words>
  <Application>Microsoft Macintosh PowerPoint</Application>
  <PresentationFormat>On-screen Show (4:3)</PresentationFormat>
  <Paragraphs>23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OHSU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ennifer Dunlap</dc:creator>
  <cp:lastModifiedBy>Jessica Leonard</cp:lastModifiedBy>
  <cp:revision>2</cp:revision>
  <dcterms:created xsi:type="dcterms:W3CDTF">2015-07-30T02:13:19Z</dcterms:created>
  <dcterms:modified xsi:type="dcterms:W3CDTF">2016-01-11T06:06:42Z</dcterms:modified>
</cp:coreProperties>
</file>